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3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theme/theme2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556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149430-3DE0-4323-B003-8C07F99F7C3D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8AC2A9-758B-48DE-A1A0-9DD7EBAE82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580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78AC2A9-758B-48DE-A1A0-9DD7EBAE82C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59126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B337C-6333-C699-38B4-FF7C75A878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2F9187-61DE-DEDC-B163-84B7B0AEC8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77964-3599-BCCA-EC11-93DAB3C6B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3F4405-3609-99F9-9A63-5EEE2CB20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DCB4F7-0FD4-B94F-B26D-3C829EFA5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9962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38ED2-7F18-D6EE-4A47-D15489F09B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2B6466-5C41-5F75-5184-A84058A866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998C88-3678-A729-75B8-E0F93162B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27DA30-7F58-FEB0-A123-67FE7AFB2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C052E1-2F0A-9AEC-8E21-F9E09C7E9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7884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8474BA-9883-FA8D-0D39-373F99ED74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71CBE6-D3E0-4D26-70DC-50CA6AF774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1A16EE-A90B-7CA5-146C-5446D71A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00FAD7-A271-8308-E5E8-30C5829BD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5E1455-134D-28FC-7487-62BE32D49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479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3036D-B14B-9A0F-D0C6-67B7D3FC47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F2A6B3-2CE1-0554-75B1-F26F49FE45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2F62E2-1E21-9034-A5CB-7DAAD6215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83B3CC-5B84-1E62-1C03-47092955C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EF9A9A-6EFD-E8CA-8A59-1402CF83D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1557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1A3E43-D3B2-EC1C-6FBB-F8F353AD25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7A4D3A-5ABD-5E6E-1B63-FAE0831F9C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760D2-3A59-6860-9A07-5FD344535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DCF4E-A357-E601-1BBD-EAEF92AD1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05EFC3-88B6-5D6D-8F1A-ABA11258B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69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746B6F-D1B9-FE25-54D9-4A99D8B85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20D89C-61B4-6458-8773-10B716F625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0E9855-2BA4-E34A-EAE8-0230615C10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218903-4CA8-26DF-091E-08C17D23E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FB48A6-1626-398C-4F82-3C200D5D5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98FB90-69E9-7728-C169-1BD084111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606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D2BA9-66CE-CB16-9845-4CEBEA607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A020D5-E557-E21A-ADD8-F36971F1A8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55FD6BA-70EF-CCA0-2AEB-FD34CD6A37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9C6B96-0C29-B2F6-13B3-E34322EF19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C865C0-7BF1-1587-26CF-BC8C4EBB02B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C5DA395-86CF-DC96-C756-CD87EA945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63A620-5748-B16C-62DF-773EA6C54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500F17-C7DD-AB91-4D51-6A890F009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161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C8D82C-501E-4576-08AE-0FCC19D654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F244A7-DE55-C8DC-DCA8-15CAAC162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ABC5AD-F083-33C7-A16A-34DBC5167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31C5DA-5794-2F7C-A98E-AA08B1461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9980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FB6B85-05A9-9058-6B1B-168E03389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8F8D3D-CEF8-0F94-4E99-845A09B20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BC41E2-AE9A-EB4D-94F0-EB38B5B47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8722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69A24-79AE-EE2C-A1CC-3DFB91F48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C1CCB7-F8AE-8A7A-E283-12D7670A3D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CF9E4D-9B06-68E0-E544-95FDF17E70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53B6F3-8F63-B070-3540-838FED22A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58C8BC-48F9-3AB0-38D6-51591112A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5D489A-110E-D9BF-D414-30D9D2285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529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5716D-0706-8814-F4BA-D4E51291AA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F75C03-DACB-3F30-B5DB-3AB6E0D722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7925F8-0D42-9E3C-BEA8-D611D799FF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F5C866-4FEC-F0D2-4ACF-59E0DBB98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0F4588-A79A-AE32-27FE-B71F815E82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C39EA1-2B09-24B8-69DD-9749CDB99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0853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DF9D6B-4DF2-C0D4-0928-F84921481E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33754B-9E5A-8D1B-82F7-C16FF1464B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C0DC0F-D0C2-9EA2-2F58-EEB9EAFB17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7D6428A-7B01-4DE4-872B-D39089F42567}" type="datetimeFigureOut">
              <a:rPr lang="en-GB" smtClean="0"/>
              <a:t>12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2790CE-DB46-CBCB-4C48-9582378529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62C947-2B66-11B7-F744-8EB06EF7E4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ADDD31-4308-446E-91B9-F5E6252CB9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2711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ack and white image of a dna strand&#10;&#10;AI-generated content may be incorrect.">
            <a:extLst>
              <a:ext uri="{FF2B5EF4-FFF2-40B4-BE49-F238E27FC236}">
                <a16:creationId xmlns:a16="http://schemas.microsoft.com/office/drawing/2014/main" id="{2CFD6507-B430-F838-416B-8A516249C0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148" y="53165"/>
            <a:ext cx="8199120" cy="585651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A570C1C-31AC-97C6-F6CF-49C8115E0375}"/>
              </a:ext>
            </a:extLst>
          </p:cNvPr>
          <p:cNvSpPr/>
          <p:nvPr/>
        </p:nvSpPr>
        <p:spPr>
          <a:xfrm>
            <a:off x="2670291" y="314422"/>
            <a:ext cx="3646715" cy="4572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420A84-6B55-D548-FAD3-A4989F8F6D9D}"/>
              </a:ext>
            </a:extLst>
          </p:cNvPr>
          <p:cNvSpPr txBox="1"/>
          <p:nvPr/>
        </p:nvSpPr>
        <p:spPr>
          <a:xfrm>
            <a:off x="2854830" y="0"/>
            <a:ext cx="3171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1        2      3      4     5       6      7    8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11021D9-8ADA-2F33-B2AE-BA94493E86EF}"/>
              </a:ext>
            </a:extLst>
          </p:cNvPr>
          <p:cNvSpPr txBox="1"/>
          <p:nvPr/>
        </p:nvSpPr>
        <p:spPr>
          <a:xfrm>
            <a:off x="2854830" y="5028718"/>
            <a:ext cx="3337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9      10   11    12     13   14   15   16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C1C17A-B6C9-355B-A054-26FBF97286B8}"/>
              </a:ext>
            </a:extLst>
          </p:cNvPr>
          <p:cNvSpPr txBox="1"/>
          <p:nvPr/>
        </p:nvSpPr>
        <p:spPr>
          <a:xfrm>
            <a:off x="8311268" y="840226"/>
            <a:ext cx="3982244" cy="47705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1 1kb ladder</a:t>
            </a:r>
          </a:p>
          <a:p>
            <a:r>
              <a:rPr lang="en-GB" sz="1600" dirty="0"/>
              <a:t>2 Uncut gDNA (0ng/ml ATC 48h)</a:t>
            </a:r>
          </a:p>
          <a:p>
            <a:r>
              <a:rPr lang="en-GB" sz="1600" dirty="0"/>
              <a:t>3 </a:t>
            </a:r>
            <a:r>
              <a:rPr lang="en-GB" sz="1600" dirty="0" err="1"/>
              <a:t>mseI</a:t>
            </a:r>
            <a:r>
              <a:rPr lang="en-GB" sz="1600" dirty="0"/>
              <a:t> digested gDNA (0ng/ml ATC 48h)</a:t>
            </a:r>
          </a:p>
          <a:p>
            <a:r>
              <a:rPr lang="en-GB" sz="1600" dirty="0"/>
              <a:t>4 </a:t>
            </a:r>
            <a:r>
              <a:rPr lang="en-GB" sz="1600" dirty="0" err="1"/>
              <a:t>salI</a:t>
            </a:r>
            <a:r>
              <a:rPr lang="en-GB" sz="1600" dirty="0"/>
              <a:t> digested gDNA (0ng/ml ATC 48h)</a:t>
            </a:r>
          </a:p>
          <a:p>
            <a:endParaRPr lang="en-GB" sz="1600" dirty="0"/>
          </a:p>
          <a:p>
            <a:r>
              <a:rPr lang="en-GB" sz="1600" dirty="0"/>
              <a:t>5 1kb ladder</a:t>
            </a:r>
          </a:p>
          <a:p>
            <a:r>
              <a:rPr lang="en-GB" sz="1600" dirty="0"/>
              <a:t>6 Uncut gDNA (0ng/ml ATC 48h)</a:t>
            </a:r>
          </a:p>
          <a:p>
            <a:r>
              <a:rPr lang="en-GB" sz="1600" dirty="0"/>
              <a:t>7 </a:t>
            </a:r>
            <a:r>
              <a:rPr lang="en-GB" sz="1600" dirty="0" err="1"/>
              <a:t>mseI</a:t>
            </a:r>
            <a:r>
              <a:rPr lang="en-GB" sz="1600" dirty="0"/>
              <a:t> digested gDNA (0ng/ml ATC 48h)</a:t>
            </a:r>
          </a:p>
          <a:p>
            <a:r>
              <a:rPr lang="en-GB" sz="1600" dirty="0"/>
              <a:t>8 </a:t>
            </a:r>
            <a:r>
              <a:rPr lang="en-GB" sz="1600" dirty="0" err="1"/>
              <a:t>salI</a:t>
            </a:r>
            <a:r>
              <a:rPr lang="en-GB" sz="1600" dirty="0"/>
              <a:t> digested gDNA (0ng/ml ATC 48h</a:t>
            </a:r>
          </a:p>
          <a:p>
            <a:endParaRPr lang="en-GB" sz="1600" dirty="0"/>
          </a:p>
          <a:p>
            <a:r>
              <a:rPr lang="en-GB" sz="1600" dirty="0"/>
              <a:t>9 1kb ladder</a:t>
            </a:r>
          </a:p>
          <a:p>
            <a:r>
              <a:rPr lang="en-GB" sz="1600" dirty="0"/>
              <a:t>10 Uncut gDNA (200ng/ml ATC 48h)</a:t>
            </a:r>
          </a:p>
          <a:p>
            <a:r>
              <a:rPr lang="en-GB" sz="1600" dirty="0"/>
              <a:t>11 </a:t>
            </a:r>
            <a:r>
              <a:rPr lang="en-GB" sz="1600" dirty="0" err="1"/>
              <a:t>mseI</a:t>
            </a:r>
            <a:r>
              <a:rPr lang="en-GB" sz="1600" dirty="0"/>
              <a:t> digested gDNA (200ng/ml ATC 48h)</a:t>
            </a:r>
          </a:p>
          <a:p>
            <a:r>
              <a:rPr lang="en-GB" sz="1600" dirty="0"/>
              <a:t>12 </a:t>
            </a:r>
            <a:r>
              <a:rPr lang="en-GB" sz="1600" dirty="0" err="1"/>
              <a:t>salI</a:t>
            </a:r>
            <a:r>
              <a:rPr lang="en-GB" sz="1600" dirty="0"/>
              <a:t> digested gDNA (200ng/ml ATC 48h</a:t>
            </a:r>
          </a:p>
          <a:p>
            <a:endParaRPr lang="en-GB" sz="1600" dirty="0"/>
          </a:p>
          <a:p>
            <a:r>
              <a:rPr lang="en-GB" sz="1600" dirty="0"/>
              <a:t>13 1kb ladder</a:t>
            </a:r>
          </a:p>
          <a:p>
            <a:r>
              <a:rPr lang="en-GB" sz="1600" dirty="0"/>
              <a:t>14 Uncut gDNA (200ng/ml ATC 48h)</a:t>
            </a:r>
          </a:p>
          <a:p>
            <a:r>
              <a:rPr lang="en-GB" sz="1600" dirty="0"/>
              <a:t>15 </a:t>
            </a:r>
            <a:r>
              <a:rPr lang="en-GB" sz="1600" dirty="0" err="1"/>
              <a:t>mseI</a:t>
            </a:r>
            <a:r>
              <a:rPr lang="en-GB" sz="1600" dirty="0"/>
              <a:t> digested gDNA (200ng/ml ATC 48h)</a:t>
            </a:r>
          </a:p>
          <a:p>
            <a:r>
              <a:rPr lang="en-GB" sz="1600" dirty="0"/>
              <a:t>16 </a:t>
            </a:r>
            <a:r>
              <a:rPr lang="en-GB" sz="1600" dirty="0" err="1"/>
              <a:t>salI</a:t>
            </a:r>
            <a:r>
              <a:rPr lang="en-GB" sz="1600" dirty="0"/>
              <a:t> digested gDNA (200ng/ml ATC 48h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1F39BE3-8FEA-E29C-F9A6-8ABBA48A9EC6}"/>
              </a:ext>
            </a:extLst>
          </p:cNvPr>
          <p:cNvCxnSpPr>
            <a:cxnSpLocks/>
          </p:cNvCxnSpPr>
          <p:nvPr/>
        </p:nvCxnSpPr>
        <p:spPr>
          <a:xfrm>
            <a:off x="4440361" y="0"/>
            <a:ext cx="53287" cy="6475228"/>
          </a:xfrm>
          <a:prstGeom prst="line">
            <a:avLst/>
          </a:prstGeom>
          <a:ln>
            <a:solidFill>
              <a:schemeClr val="bg1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75A0476-A937-85AD-1C8A-F461BB0D3AD3}"/>
              </a:ext>
            </a:extLst>
          </p:cNvPr>
          <p:cNvSpPr txBox="1"/>
          <p:nvPr/>
        </p:nvSpPr>
        <p:spPr>
          <a:xfrm>
            <a:off x="4626788" y="5955517"/>
            <a:ext cx="6583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el cut and transferred for anti-dsDNA blot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FB6592D-B882-200D-A99D-6CFDFDC10A66}"/>
              </a:ext>
            </a:extLst>
          </p:cNvPr>
          <p:cNvSpPr txBox="1"/>
          <p:nvPr/>
        </p:nvSpPr>
        <p:spPr>
          <a:xfrm>
            <a:off x="194208" y="5965507"/>
            <a:ext cx="4804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Gel cut and transferred for anti-</a:t>
            </a:r>
            <a:r>
              <a:rPr lang="en-GB" dirty="0" err="1"/>
              <a:t>ADPr</a:t>
            </a:r>
            <a:r>
              <a:rPr lang="en-GB" dirty="0"/>
              <a:t> blot </a:t>
            </a:r>
          </a:p>
        </p:txBody>
      </p:sp>
    </p:spTree>
    <p:extLst>
      <p:ext uri="{BB962C8B-B14F-4D97-AF65-F5344CB8AC3E}">
        <p14:creationId xmlns:p14="http://schemas.microsoft.com/office/powerpoint/2010/main" val="1180016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598730C5DFCF246B154C9145A71693D" ma:contentTypeVersion="12" ma:contentTypeDescription="Create a new document." ma:contentTypeScope="" ma:versionID="ae7b9c86051f4e040dac568b69fb0128">
  <xsd:schema xmlns:xsd="http://www.w3.org/2001/XMLSchema" xmlns:xs="http://www.w3.org/2001/XMLSchema" xmlns:p="http://schemas.microsoft.com/office/2006/metadata/properties" xmlns:ns2="3d001f60-a2d7-4d7d-b13f-e8538330c949" xmlns:ns3="33967b2d-0c2e-4b90-8b20-39fe1832c3e1" targetNamespace="http://schemas.microsoft.com/office/2006/metadata/properties" ma:root="true" ma:fieldsID="757bba51fdd94759903aa6d2e9861751" ns2:_="" ns3:_="">
    <xsd:import namespace="3d001f60-a2d7-4d7d-b13f-e8538330c949"/>
    <xsd:import namespace="33967b2d-0c2e-4b90-8b20-39fe1832c3e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LengthInSecond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d001f60-a2d7-4d7d-b13f-e8538330c9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58692e38-9dd4-4db7-af25-16fcd4767bb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3967b2d-0c2e-4b90-8b20-39fe1832c3e1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5c77dd19-a496-43b3-950e-f870f8ef18e7}" ma:internalName="TaxCatchAll" ma:showField="CatchAllData" ma:web="33967b2d-0c2e-4b90-8b20-39fe1832c3e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d001f60-a2d7-4d7d-b13f-e8538330c949">
      <Terms xmlns="http://schemas.microsoft.com/office/infopath/2007/PartnerControls"/>
    </lcf76f155ced4ddcb4097134ff3c332f>
    <TaxCatchAll xmlns="33967b2d-0c2e-4b90-8b20-39fe1832c3e1" xsi:nil="true"/>
  </documentManagement>
</p:properties>
</file>

<file path=customXml/itemProps1.xml><?xml version="1.0" encoding="utf-8"?>
<ds:datastoreItem xmlns:ds="http://schemas.openxmlformats.org/officeDocument/2006/customXml" ds:itemID="{F4A72CD8-17A0-4177-8F2D-F2FBECEA94B5}"/>
</file>

<file path=customXml/itemProps2.xml><?xml version="1.0" encoding="utf-8"?>
<ds:datastoreItem xmlns:ds="http://schemas.openxmlformats.org/officeDocument/2006/customXml" ds:itemID="{8663F0A7-1BC5-4DD8-A28F-3FFEA7C7F846}"/>
</file>

<file path=customXml/itemProps3.xml><?xml version="1.0" encoding="utf-8"?>
<ds:datastoreItem xmlns:ds="http://schemas.openxmlformats.org/officeDocument/2006/customXml" ds:itemID="{EFEC439C-EDDE-44E2-8BAC-451446CEE4B6}"/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68</Words>
  <Application>Microsoft Office PowerPoint</Application>
  <PresentationFormat>Widescreen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tler, Rachel Dr (Sch of Biosciences)</dc:creator>
  <cp:lastModifiedBy>Butler, Rachel Dr (Sch of Biosciences)</cp:lastModifiedBy>
  <cp:revision>1</cp:revision>
  <dcterms:created xsi:type="dcterms:W3CDTF">2025-03-12T11:39:55Z</dcterms:created>
  <dcterms:modified xsi:type="dcterms:W3CDTF">2025-03-12T11:50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98730C5DFCF246B154C9145A71693D</vt:lpwstr>
  </property>
</Properties>
</file>